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4" autoAdjust="0"/>
    <p:restoredTop sz="94679"/>
  </p:normalViewPr>
  <p:slideViewPr>
    <p:cSldViewPr snapToGrid="0">
      <p:cViewPr varScale="1">
        <p:scale>
          <a:sx n="88" d="100"/>
          <a:sy n="88" d="100"/>
        </p:scale>
        <p:origin x="1282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A969-4081-4ECB-B823-1F718DB837D3}" type="datetimeFigureOut">
              <a:rPr lang="es-ES" smtClean="0"/>
              <a:t>13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78C8E-73F9-456F-B85E-ECA1CEF80A4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31617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A969-4081-4ECB-B823-1F718DB837D3}" type="datetimeFigureOut">
              <a:rPr lang="es-ES" smtClean="0"/>
              <a:t>13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78C8E-73F9-456F-B85E-ECA1CEF80A4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30465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A969-4081-4ECB-B823-1F718DB837D3}" type="datetimeFigureOut">
              <a:rPr lang="es-ES" smtClean="0"/>
              <a:t>13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78C8E-73F9-456F-B85E-ECA1CEF80A4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2976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A969-4081-4ECB-B823-1F718DB837D3}" type="datetimeFigureOut">
              <a:rPr lang="es-ES" smtClean="0"/>
              <a:t>13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78C8E-73F9-456F-B85E-ECA1CEF80A4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5311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A969-4081-4ECB-B823-1F718DB837D3}" type="datetimeFigureOut">
              <a:rPr lang="es-ES" smtClean="0"/>
              <a:t>13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78C8E-73F9-456F-B85E-ECA1CEF80A4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912692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A969-4081-4ECB-B823-1F718DB837D3}" type="datetimeFigureOut">
              <a:rPr lang="es-ES" smtClean="0"/>
              <a:t>13/02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78C8E-73F9-456F-B85E-ECA1CEF80A4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47170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A969-4081-4ECB-B823-1F718DB837D3}" type="datetimeFigureOut">
              <a:rPr lang="es-ES" smtClean="0"/>
              <a:t>13/02/202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78C8E-73F9-456F-B85E-ECA1CEF80A4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0911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A969-4081-4ECB-B823-1F718DB837D3}" type="datetimeFigureOut">
              <a:rPr lang="es-ES" smtClean="0"/>
              <a:t>13/02/202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78C8E-73F9-456F-B85E-ECA1CEF80A4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1588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A969-4081-4ECB-B823-1F718DB837D3}" type="datetimeFigureOut">
              <a:rPr lang="es-ES" smtClean="0"/>
              <a:t>13/02/202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78C8E-73F9-456F-B85E-ECA1CEF80A4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5495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A969-4081-4ECB-B823-1F718DB837D3}" type="datetimeFigureOut">
              <a:rPr lang="es-ES" smtClean="0"/>
              <a:t>13/02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78C8E-73F9-456F-B85E-ECA1CEF80A4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38244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A969-4081-4ECB-B823-1F718DB837D3}" type="datetimeFigureOut">
              <a:rPr lang="es-ES" smtClean="0"/>
              <a:t>13/02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78C8E-73F9-456F-B85E-ECA1CEF80A4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14132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0E8A969-4081-4ECB-B823-1F718DB837D3}" type="datetimeFigureOut">
              <a:rPr lang="es-ES" smtClean="0"/>
              <a:t>13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AB78C8E-73F9-456F-B85E-ECA1CEF80A4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27734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FC7BB062-B98F-401C-0C18-ACD45546CDF7}"/>
              </a:ext>
            </a:extLst>
          </p:cNvPr>
          <p:cNvSpPr txBox="1"/>
          <p:nvPr/>
        </p:nvSpPr>
        <p:spPr>
          <a:xfrm>
            <a:off x="1622945" y="5226692"/>
            <a:ext cx="6040875" cy="115891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ctr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s-ES" sz="10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a S3.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ultidimensional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caling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MDS)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lot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sed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ean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alues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rived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RBS data,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lustrating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NA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thylation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tterns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onadal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issue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i="1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lea </a:t>
            </a:r>
            <a:r>
              <a:rPr lang="es-ES" sz="1000" i="1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negalensis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mples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rrespond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ur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xperimental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oups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fined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ex (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emale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male) and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igin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wild-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ype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rst-generation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aptive-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red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F1). Individual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mples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ed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s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abeled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ints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lored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cording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ir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espective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oups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F1F (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ange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tF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iolet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F1M (blue),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tM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een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ances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ints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flect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elative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milarity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global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thylation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files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F1F: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rst-generation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aptive-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red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emale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tF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wild-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ype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emale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F1M: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rst-generation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aptive-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red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ale, and 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tM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wild-</a:t>
            </a:r>
            <a:r>
              <a:rPr lang="es-ES" sz="1000" dirty="0" err="1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ype</a:t>
            </a:r>
            <a:r>
              <a:rPr lang="es-ES" sz="1000" dirty="0">
                <a:solidFill>
                  <a:srgbClr val="FF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ale</a:t>
            </a:r>
            <a:r>
              <a:rPr lang="es-ES" sz="10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s-ES" sz="10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9" name="Imagen 58">
            <a:extLst>
              <a:ext uri="{FF2B5EF4-FFF2-40B4-BE49-F238E27FC236}">
                <a16:creationId xmlns:a16="http://schemas.microsoft.com/office/drawing/2014/main" id="{D60FBB5D-13E6-AF57-2392-E1BC2A501B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7199" y="87319"/>
            <a:ext cx="6669602" cy="51393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168363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</TotalTime>
  <Words>123</Words>
  <Application>Microsoft Office PowerPoint</Application>
  <PresentationFormat>Presentación en pantalla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Daniel Ramírez Torres</dc:creator>
  <cp:lastModifiedBy>Esther</cp:lastModifiedBy>
  <cp:revision>6</cp:revision>
  <dcterms:created xsi:type="dcterms:W3CDTF">2026-02-04T11:38:40Z</dcterms:created>
  <dcterms:modified xsi:type="dcterms:W3CDTF">2026-02-13T12:55:10Z</dcterms:modified>
</cp:coreProperties>
</file>